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04" autoAdjust="0"/>
    <p:restoredTop sz="94660"/>
  </p:normalViewPr>
  <p:slideViewPr>
    <p:cSldViewPr snapToGrid="0">
      <p:cViewPr varScale="1">
        <p:scale>
          <a:sx n="83" d="100"/>
          <a:sy n="83" d="100"/>
        </p:scale>
        <p:origin x="321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dots&#10;&#10;AI-generated content may be incorrect.">
            <a:extLst>
              <a:ext uri="{FF2B5EF4-FFF2-40B4-BE49-F238E27FC236}">
                <a16:creationId xmlns:a16="http://schemas.microsoft.com/office/drawing/2014/main" id="{F7CB4687-395E-DC70-2C52-F4F29FFEDF91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339790" y="399245"/>
            <a:ext cx="3736632" cy="304505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9D9D2F2-9BB8-7F56-481B-68F4BB76AC1B}"/>
              </a:ext>
            </a:extLst>
          </p:cNvPr>
          <p:cNvSpPr txBox="1"/>
          <p:nvPr/>
        </p:nvSpPr>
        <p:spPr>
          <a:xfrm>
            <a:off x="232354" y="3698421"/>
            <a:ext cx="6393292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Endosteal mesenchymal clusters isolated from young and old male mice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form manifold approximation and projection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MAP) visualization of mesenchymal cells from endosteal bone preparations of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young (6 months) or old (24 months) wild-type male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names and color codes are indicated at the right.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list of different colored circles&#10;&#10;Description automatically generated">
            <a:extLst>
              <a:ext uri="{FF2B5EF4-FFF2-40B4-BE49-F238E27FC236}">
                <a16:creationId xmlns:a16="http://schemas.microsoft.com/office/drawing/2014/main" id="{2587F6C8-D0D4-00B3-99B1-0E2CEF627C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206" y="942004"/>
            <a:ext cx="1104516" cy="1887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0077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21</TotalTime>
  <Words>5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70</cp:revision>
  <cp:lastPrinted>2024-12-12T18:09:24Z</cp:lastPrinted>
  <dcterms:created xsi:type="dcterms:W3CDTF">2024-09-05T13:29:40Z</dcterms:created>
  <dcterms:modified xsi:type="dcterms:W3CDTF">2025-07-03T15:48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